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handoutMasterIdLst>
    <p:handoutMasterId r:id="rId5"/>
  </p:handoutMasterIdLst>
  <p:sldIdLst>
    <p:sldId id="275" r:id="rId2"/>
    <p:sldId id="277" r:id="rId3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79D8F79-E8BB-B60F-6D93-B05FDC133A9C}" name="Christiane Schnabel" initials="CS" userId="2a610aa8e4517a4d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idel, Anne-Marie" initials="SA" lastIdx="5" clrIdx="0">
    <p:extLst>
      <p:ext uri="{19B8F6BF-5375-455C-9EA6-DF929625EA0E}">
        <p15:presenceInfo xmlns:p15="http://schemas.microsoft.com/office/powerpoint/2012/main" userId="S-1-5-21-2361800232-213331468-3115616407-387558" providerId="AD"/>
      </p:ext>
    </p:extLst>
  </p:cmAuthor>
  <p:cmAuthor id="2" name="Maria Eschke" initials="UL" lastIdx="22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Eschke, Maria" initials="EM" lastIdx="3" clrIdx="2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4" name="Alber, Gottfried" initials="AG" lastIdx="2" clrIdx="3">
    <p:extLst>
      <p:ext uri="{19B8F6BF-5375-455C-9EA6-DF929625EA0E}">
        <p15:presenceInfo xmlns:p15="http://schemas.microsoft.com/office/powerpoint/2012/main" userId="S-1-5-21-2361800232-213331468-3115616407-431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FDFDFD"/>
    <a:srgbClr val="FFFFFF"/>
    <a:srgbClr val="FEF8FA"/>
    <a:srgbClr val="FCE8F5"/>
    <a:srgbClr val="F8CCE8"/>
    <a:srgbClr val="ED7F05"/>
    <a:srgbClr val="FBA84D"/>
    <a:srgbClr val="FF535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6" autoAdjust="0"/>
    <p:restoredTop sz="96250" autoAdjust="0"/>
  </p:normalViewPr>
  <p:slideViewPr>
    <p:cSldViewPr snapToGrid="0">
      <p:cViewPr varScale="1">
        <p:scale>
          <a:sx n="65" d="100"/>
          <a:sy n="65" d="100"/>
        </p:scale>
        <p:origin x="2644" y="72"/>
      </p:cViewPr>
      <p:guideLst>
        <p:guide orient="horz" pos="557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3" d="100"/>
          <a:sy n="83" d="100"/>
        </p:scale>
        <p:origin x="3168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5" Type="http://schemas.microsoft.com/office/2018/10/relationships/authors" Target="authors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160072-A28E-46E2-AA8C-7CC077433761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9A1FE-545D-4171-9562-764BF926DC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03162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78878-7DF9-4246-A989-EB0D19A20006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170363" y="850900"/>
            <a:ext cx="1585912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92665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C71C09-CA1E-47D9-B086-5D0740769A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201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7478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43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7166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9475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9579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7803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9307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2562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74664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4251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5282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0A60D-4029-4E87-BFB1-58DA8EC0EF9B}" type="datetimeFigureOut">
              <a:rPr lang="de-DE" smtClean="0"/>
              <a:t>04.1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BCD1FB-8F1B-417E-9F0A-C848B49DC5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649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106948" y="4196975"/>
            <a:ext cx="6661304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endParaRPr lang="en-GB" sz="1200" b="1" dirty="0">
              <a:solidFill>
                <a:srgbClr val="5B9BD5">
                  <a:lumMod val="75000"/>
                </a:srgbClr>
              </a:solidFill>
              <a:ea typeface="MS PGothic" panose="020B0600070205080204" pitchFamily="34" charset="-128"/>
            </a:endParaRP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M is not critical for the survival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p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in blood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weeks-ol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gs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of 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p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strain 10 was assessed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the blood drawn from the same pigs at four and eight weeks of age in the presence/absence of the specific IgM protease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de</a:t>
            </a:r>
            <a:r>
              <a:rPr lang="en-US" sz="1200" i="1" baseline="-25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uis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survival factor represents the ratio of </a:t>
            </a:r>
            <a:r>
              <a:rPr lang="da-DK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FU at 120 min to CFU at time zero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factors above one (dotted line) indicate proliferation of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ble survival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p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strain 10 in the blood of the same pigs at four and eight weeks of age.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g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analysis was performed us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ed t-tes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two-tailed, * p&lt;0.05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effect of the IgM proteas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</a:t>
            </a:r>
            <a:r>
              <a:rPr lang="en-US" sz="12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u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 the survival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p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in blood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weeks-ol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gs.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analysis was performed using Wilcoxon matched-pairs signed-rank test. 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9712" y="355795"/>
            <a:ext cx="498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3358218" y="355795"/>
            <a:ext cx="573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</a:t>
            </a:r>
          </a:p>
        </p:txBody>
      </p:sp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C8A99DE7-34B9-43C6-9E33-B941D4B60D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3553265"/>
              </p:ext>
            </p:extLst>
          </p:nvPr>
        </p:nvGraphicFramePr>
        <p:xfrm>
          <a:off x="3617913" y="842695"/>
          <a:ext cx="3143250" cy="2800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2" name="Prism 10" r:id="rId3" imgW="2738112" imgH="2405829" progId="Prism10.Document">
                  <p:embed/>
                </p:oleObj>
              </mc:Choice>
              <mc:Fallback>
                <p:oleObj name="Prism 10" r:id="rId3" imgW="2738112" imgH="2405829" progId="Prism10.Document">
                  <p:embed/>
                  <p:pic>
                    <p:nvPicPr>
                      <p:cNvPr id="17" name="Objekt 16">
                        <a:extLst>
                          <a:ext uri="{FF2B5EF4-FFF2-40B4-BE49-F238E27FC236}">
                            <a16:creationId xmlns:a16="http://schemas.microsoft.com/office/drawing/2014/main" id="{C8A99DE7-34B9-43C6-9E33-B941D4B60D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17913" y="842695"/>
                        <a:ext cx="3143250" cy="2800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29590F71-BB5F-470E-973D-5928D6B257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6474342"/>
              </p:ext>
            </p:extLst>
          </p:nvPr>
        </p:nvGraphicFramePr>
        <p:xfrm>
          <a:off x="19712" y="872364"/>
          <a:ext cx="3417888" cy="335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3" name="Prism 10" r:id="rId5" imgW="3046028" imgH="2991439" progId="Prism10.Document">
                  <p:embed/>
                </p:oleObj>
              </mc:Choice>
              <mc:Fallback>
                <p:oleObj name="Prism 10" r:id="rId5" imgW="3046028" imgH="2991439" progId="Prism10.Document">
                  <p:embed/>
                  <p:pic>
                    <p:nvPicPr>
                      <p:cNvPr id="9" name="Objekt 8">
                        <a:extLst>
                          <a:ext uri="{FF2B5EF4-FFF2-40B4-BE49-F238E27FC236}">
                            <a16:creationId xmlns:a16="http://schemas.microsoft.com/office/drawing/2014/main" id="{29590F71-BB5F-470E-973D-5928D6B257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712" y="872364"/>
                        <a:ext cx="3417888" cy="335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96846903-B48A-4C81-AC38-013E323B8A50}"/>
              </a:ext>
            </a:extLst>
          </p:cNvPr>
          <p:cNvSpPr txBox="1"/>
          <p:nvPr/>
        </p:nvSpPr>
        <p:spPr>
          <a:xfrm>
            <a:off x="5039260" y="309628"/>
            <a:ext cx="94032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algn="ctr">
              <a:defRPr sz="1050"/>
            </a:lvl1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rPr>
              <a:t>4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rPr>
              <a:t>weeks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466643" y="872364"/>
            <a:ext cx="86113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600" i="1" dirty="0"/>
              <a:t>p</a:t>
            </a:r>
            <a:r>
              <a:rPr lang="de-DE" sz="1600" dirty="0"/>
              <a:t>=0.318</a:t>
            </a:r>
            <a:endParaRPr lang="de-DE" sz="1600" i="1" dirty="0"/>
          </a:p>
        </p:txBody>
      </p:sp>
      <p:sp>
        <p:nvSpPr>
          <p:cNvPr id="10" name="Textfeld 9"/>
          <p:cNvSpPr txBox="1"/>
          <p:nvPr/>
        </p:nvSpPr>
        <p:spPr>
          <a:xfrm>
            <a:off x="5118449" y="843336"/>
            <a:ext cx="86113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600" i="1" dirty="0"/>
              <a:t>p</a:t>
            </a:r>
            <a:r>
              <a:rPr lang="de-DE" sz="1600" dirty="0"/>
              <a:t>=0.562</a:t>
            </a:r>
            <a:endParaRPr lang="de-DE" sz="1600" i="1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36D9011E-B388-46AD-B6BD-32C3DF507426}"/>
              </a:ext>
            </a:extLst>
          </p:cNvPr>
          <p:cNvSpPr/>
          <p:nvPr/>
        </p:nvSpPr>
        <p:spPr>
          <a:xfrm>
            <a:off x="3927915" y="3632985"/>
            <a:ext cx="1055923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rPr>
              <a:t>Ide</a:t>
            </a:r>
            <a:r>
              <a:rPr kumimoji="0" lang="de-DE" sz="1400" b="1" i="1" u="none" strike="noStrike" kern="1200" cap="none" spc="0" normalizeH="0" baseline="-2500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+mn-ea"/>
                <a:cs typeface="Arial" panose="020B0604020202020204" pitchFamily="34" charset="0"/>
              </a:rPr>
              <a:t>Ssuis</a:t>
            </a:r>
            <a:endParaRPr kumimoji="0" lang="de-DE" sz="1400" b="1" i="1" u="none" strike="noStrike" kern="1200" cap="none" spc="0" normalizeH="0" baseline="-25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3091187E-F622-487B-B8AC-22B70D907FAF}"/>
              </a:ext>
            </a:extLst>
          </p:cNvPr>
          <p:cNvSpPr/>
          <p:nvPr/>
        </p:nvSpPr>
        <p:spPr>
          <a:xfrm>
            <a:off x="4978046" y="3653723"/>
            <a:ext cx="171129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defRPr/>
            </a:pPr>
            <a:r>
              <a:rPr lang="en-US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endParaRPr kumimoji="0" lang="de-DE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BED33350-D135-40C8-9102-B97448958951}"/>
              </a:ext>
            </a:extLst>
          </p:cNvPr>
          <p:cNvSpPr/>
          <p:nvPr/>
        </p:nvSpPr>
        <p:spPr>
          <a:xfrm>
            <a:off x="5612290" y="3586641"/>
            <a:ext cx="1134359" cy="2339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3266A1DB-90AE-4D2D-A8A0-E2A06D6A1F05}"/>
              </a:ext>
            </a:extLst>
          </p:cNvPr>
          <p:cNvSpPr/>
          <p:nvPr/>
        </p:nvSpPr>
        <p:spPr>
          <a:xfrm>
            <a:off x="6027694" y="3602207"/>
            <a:ext cx="171129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27898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73152" y="3184337"/>
            <a:ext cx="67116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srgbClr val="5B9BD5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MS PGothic" panose="020B0600070205080204" pitchFamily="34" charset="-128"/>
              <a:cs typeface="+mn-cs"/>
            </a:endParaRPr>
          </a:p>
          <a:p>
            <a:pPr lvl="0" algn="just"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2: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rrelation between the</a:t>
            </a:r>
            <a:r>
              <a:rPr kumimoji="0" lang="en-US" sz="12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vel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f anti-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. </a:t>
            </a:r>
            <a:r>
              <a:rPr kumimoji="0" lang="en-US" sz="1200" b="1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i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gM and the level of total IgM in 8-weeks-old pigs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, that for statistical robustness pooled data of two independent experiments were included in correlation analysis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: Pearson correlation coefficient; * p&lt;0.05, two-tailed).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B4C4DE0A-A1F7-4506-8871-F77546C0C8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2835" y="-431516"/>
            <a:ext cx="675498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802F64D4-295A-4478-A210-164BBF1C6A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7638123"/>
              </p:ext>
            </p:extLst>
          </p:nvPr>
        </p:nvGraphicFramePr>
        <p:xfrm>
          <a:off x="1030513" y="394834"/>
          <a:ext cx="4599668" cy="28398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6" name="Prism 10" r:id="rId3" imgW="4355841" imgH="2686389" progId="Prism10.Document">
                  <p:embed/>
                </p:oleObj>
              </mc:Choice>
              <mc:Fallback>
                <p:oleObj name="Prism 10" r:id="rId3" imgW="4355841" imgH="2686389" progId="Prism10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30513" y="394834"/>
                        <a:ext cx="4599668" cy="283986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26374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5</Words>
  <Application>Microsoft Office PowerPoint</Application>
  <PresentationFormat>A4-Papier (210 x 297 mm)</PresentationFormat>
  <Paragraphs>12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9" baseType="lpstr">
      <vt:lpstr>MS PGothic</vt:lpstr>
      <vt:lpstr>Arial</vt:lpstr>
      <vt:lpstr>Calibri</vt:lpstr>
      <vt:lpstr>Calibri Light</vt:lpstr>
      <vt:lpstr>Times New Roman</vt:lpstr>
      <vt:lpstr>Office</vt:lpstr>
      <vt:lpstr>Prism 10</vt:lpstr>
      <vt:lpstr>PowerPoint-Präsentation</vt:lpstr>
      <vt:lpstr>PowerPoint-Präsentation</vt:lpstr>
    </vt:vector>
  </TitlesOfParts>
  <Company>Universität Leipzig BB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idel, Anne-Marie</dc:creator>
  <cp:lastModifiedBy>Maria Eschke</cp:lastModifiedBy>
  <cp:revision>471</cp:revision>
  <cp:lastPrinted>2024-08-06T12:34:37Z</cp:lastPrinted>
  <dcterms:created xsi:type="dcterms:W3CDTF">2024-01-25T12:16:18Z</dcterms:created>
  <dcterms:modified xsi:type="dcterms:W3CDTF">2024-11-04T14:36:19Z</dcterms:modified>
</cp:coreProperties>
</file>